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71" r:id="rId2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8" d="100"/>
          <a:sy n="78" d="100"/>
        </p:scale>
        <p:origin x="303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 hasCustomPrompt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dirty="0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8"/>
          <p:cNvSpPr txBox="1"/>
          <p:nvPr/>
        </p:nvSpPr>
        <p:spPr>
          <a:xfrm>
            <a:off x="78945" y="62751"/>
            <a:ext cx="20553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kumimoji="1"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2442526" y="1753522"/>
            <a:ext cx="10597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utoff </a:t>
            </a:r>
          </a:p>
          <a:p>
            <a:pPr algn="l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1.125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pg/ml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19"/>
          <p:cNvSpPr txBox="1"/>
          <p:nvPr/>
        </p:nvSpPr>
        <p:spPr>
          <a:xfrm>
            <a:off x="2442526" y="3962052"/>
            <a:ext cx="10711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utoff</a:t>
            </a:r>
          </a:p>
          <a:p>
            <a:pPr algn="l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57.31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pg/ml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19"/>
          <p:cNvSpPr txBox="1"/>
          <p:nvPr/>
        </p:nvSpPr>
        <p:spPr>
          <a:xfrm>
            <a:off x="2442526" y="6185187"/>
            <a:ext cx="10711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utoff</a:t>
            </a:r>
          </a:p>
          <a:p>
            <a:pPr algn="l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54.47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pg/ml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19"/>
          <p:cNvSpPr txBox="1"/>
          <p:nvPr/>
        </p:nvSpPr>
        <p:spPr>
          <a:xfrm>
            <a:off x="5588316" y="1753522"/>
            <a:ext cx="10711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utoff</a:t>
            </a:r>
          </a:p>
          <a:p>
            <a:pPr algn="l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104.4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g/ml</a:t>
            </a:r>
          </a:p>
        </p:txBody>
      </p:sp>
      <p:sp>
        <p:nvSpPr>
          <p:cNvPr id="7" name="テキスト ボックス 19"/>
          <p:cNvSpPr txBox="1"/>
          <p:nvPr/>
        </p:nvSpPr>
        <p:spPr>
          <a:xfrm>
            <a:off x="5588316" y="3962052"/>
            <a:ext cx="10711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utoff</a:t>
            </a:r>
          </a:p>
          <a:p>
            <a:pPr algn="l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54.91</a:t>
            </a:r>
            <a:r>
              <a:rPr kumimoji="1"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pg/ml</a:t>
            </a:r>
            <a:endParaRPr kumimoji="1"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19"/>
          <p:cNvSpPr txBox="1"/>
          <p:nvPr/>
        </p:nvSpPr>
        <p:spPr>
          <a:xfrm>
            <a:off x="5588316" y="6185187"/>
            <a:ext cx="98616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utoff </a:t>
            </a:r>
          </a:p>
          <a:p>
            <a:pPr algn="l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3.02</a:t>
            </a:r>
            <a:r>
              <a:rPr kumimoji="1"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pg/ml</a:t>
            </a:r>
            <a:endParaRPr kumimoji="1"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18"/>
          <p:cNvSpPr txBox="1"/>
          <p:nvPr/>
        </p:nvSpPr>
        <p:spPr>
          <a:xfrm>
            <a:off x="5588316" y="4455217"/>
            <a:ext cx="9813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UC=0.750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kumimoji="1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=0.289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8"/>
          <p:cNvSpPr txBox="1"/>
          <p:nvPr/>
        </p:nvSpPr>
        <p:spPr>
          <a:xfrm>
            <a:off x="2442526" y="2231447"/>
            <a:ext cx="9813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UC=0.583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kumimoji="1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=0.724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8"/>
          <p:cNvSpPr txBox="1"/>
          <p:nvPr/>
        </p:nvSpPr>
        <p:spPr>
          <a:xfrm>
            <a:off x="5588316" y="2231447"/>
            <a:ext cx="9813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UC=0.750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kumimoji="1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=0.289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8"/>
          <p:cNvSpPr txBox="1"/>
          <p:nvPr/>
        </p:nvSpPr>
        <p:spPr>
          <a:xfrm>
            <a:off x="5588316" y="6669462"/>
            <a:ext cx="9813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UC=0.583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kumimoji="1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=0.724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612861" y="626140"/>
            <a:ext cx="5427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dirty="0" smtClean="0"/>
              <a:t>ROC curve predicting efficacy of anti-PD-1 monotherapy</a:t>
            </a:r>
            <a:endParaRPr kumimoji="1" lang="en-US" dirty="0"/>
          </a:p>
        </p:txBody>
      </p:sp>
      <p:sp>
        <p:nvSpPr>
          <p:cNvPr id="34" name="テキスト ボックス 18"/>
          <p:cNvSpPr txBox="1"/>
          <p:nvPr/>
        </p:nvSpPr>
        <p:spPr>
          <a:xfrm>
            <a:off x="1436254" y="1345250"/>
            <a:ext cx="884555" cy="3048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CTLA-4</a:t>
            </a:r>
          </a:p>
        </p:txBody>
      </p:sp>
      <p:sp>
        <p:nvSpPr>
          <p:cNvPr id="35" name="テキスト ボックス 18"/>
          <p:cNvSpPr txBox="1"/>
          <p:nvPr/>
        </p:nvSpPr>
        <p:spPr>
          <a:xfrm>
            <a:off x="1490546" y="3642680"/>
            <a:ext cx="775970" cy="3048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PD-L1</a:t>
            </a:r>
          </a:p>
        </p:txBody>
      </p:sp>
      <p:sp>
        <p:nvSpPr>
          <p:cNvPr id="36" name="テキスト ボックス 18"/>
          <p:cNvSpPr txBox="1"/>
          <p:nvPr/>
        </p:nvSpPr>
        <p:spPr>
          <a:xfrm>
            <a:off x="1540076" y="5857560"/>
            <a:ext cx="676910" cy="3048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PD-1</a:t>
            </a:r>
          </a:p>
        </p:txBody>
      </p:sp>
      <p:sp>
        <p:nvSpPr>
          <p:cNvPr id="37" name="テキスト ボックス 18"/>
          <p:cNvSpPr txBox="1"/>
          <p:nvPr/>
        </p:nvSpPr>
        <p:spPr>
          <a:xfrm>
            <a:off x="4309224" y="1345250"/>
            <a:ext cx="7072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kumimoji="1" lang="en-US" altLang="ja-JP" sz="14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kumimoji="1" lang="en-US" altLang="ja-JP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8" name="テキスト ボックス 18"/>
          <p:cNvSpPr txBox="1"/>
          <p:nvPr/>
        </p:nvSpPr>
        <p:spPr>
          <a:xfrm>
            <a:off x="4309224" y="3642680"/>
            <a:ext cx="7072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kumimoji="1" lang="en-US" altLang="ja-JP" sz="14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kumimoji="1" lang="en-US" altLang="ja-JP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9" name="テキスト ボックス 18"/>
          <p:cNvSpPr txBox="1"/>
          <p:nvPr/>
        </p:nvSpPr>
        <p:spPr>
          <a:xfrm>
            <a:off x="4309224" y="5857560"/>
            <a:ext cx="7072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kumimoji="1" lang="en-US" altLang="ja-JP" sz="14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kumimoji="1" lang="en-US" altLang="ja-JP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2" name="テキスト ボックス 18"/>
          <p:cNvSpPr txBox="1"/>
          <p:nvPr/>
        </p:nvSpPr>
        <p:spPr>
          <a:xfrm>
            <a:off x="2442526" y="4455217"/>
            <a:ext cx="9813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UC=0.667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kumimoji="1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=0.480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8"/>
          <p:cNvSpPr txBox="1"/>
          <p:nvPr/>
        </p:nvSpPr>
        <p:spPr>
          <a:xfrm>
            <a:off x="2442526" y="6669462"/>
            <a:ext cx="9813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UC=0.833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kumimoji="1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=0.157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図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8355" y="1637764"/>
            <a:ext cx="1800000" cy="1578962"/>
          </a:xfrm>
          <a:prstGeom prst="rect">
            <a:avLst/>
          </a:prstGeom>
        </p:spPr>
      </p:pic>
      <p:pic>
        <p:nvPicPr>
          <p:cNvPr id="16" name="図 1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8355" y="3944674"/>
            <a:ext cx="1800000" cy="1557406"/>
          </a:xfrm>
          <a:prstGeom prst="rect">
            <a:avLst/>
          </a:prstGeom>
        </p:spPr>
      </p:pic>
      <p:pic>
        <p:nvPicPr>
          <p:cNvPr id="17" name="図 1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8355" y="6236006"/>
            <a:ext cx="1800000" cy="1612762"/>
          </a:xfrm>
          <a:prstGeom prst="rect">
            <a:avLst/>
          </a:prstGeom>
        </p:spPr>
      </p:pic>
      <p:pic>
        <p:nvPicPr>
          <p:cNvPr id="18" name="図 1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06100" y="1637764"/>
            <a:ext cx="1800000" cy="1578962"/>
          </a:xfrm>
          <a:prstGeom prst="rect">
            <a:avLst/>
          </a:prstGeom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06100" y="3923118"/>
            <a:ext cx="1800000" cy="1578962"/>
          </a:xfrm>
          <a:prstGeom prst="rect">
            <a:avLst/>
          </a:prstGeom>
        </p:spPr>
      </p:pic>
      <p:pic>
        <p:nvPicPr>
          <p:cNvPr id="20" name="図 1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06100" y="6236006"/>
            <a:ext cx="1800000" cy="16226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63488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290</TotalTime>
  <Words>47</Words>
  <Application>Microsoft Office PowerPoint</Application>
  <PresentationFormat>A4 210 x 297 mm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Symbo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沖田 理貴</dc:creator>
  <cp:lastModifiedBy>沖田 理貴</cp:lastModifiedBy>
  <cp:revision>60</cp:revision>
  <cp:lastPrinted>2024-02-06T00:41:35Z</cp:lastPrinted>
  <dcterms:created xsi:type="dcterms:W3CDTF">2024-01-07T23:36:00Z</dcterms:created>
  <dcterms:modified xsi:type="dcterms:W3CDTF">2024-04-02T01:19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41-10.8.0.5773</vt:lpwstr>
  </property>
</Properties>
</file>